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DCC6DF-02B8-40E5-8007-3DED71E5A23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34012E-D653-447C-BE35-1BA2EF9F05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083BE3-AF61-4F33-94E6-38078558B8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B29F35-70B1-4762-B961-DC851688B24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5172D7-3729-4F60-8793-3E91FF3640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B5419F-37EE-4DC7-893E-61A3EE8FD3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62C5D1-60E7-47E7-9002-8599F10B22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9AF78A-FC57-4CB9-9933-48CCF13824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DB5BE9-1014-4ED8-9F94-DCC51F7D33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2261F4-6268-4E19-83A9-BEC45E0639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B369B3-B6B4-42F5-8EB8-B5EFB17085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5B6F0E-7E04-4086-8E52-2D110B88E2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6B6622-CF6D-4C10-8E8A-12FB8FA5A22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2"/>
          <p:cNvSpPr/>
          <p:nvPr/>
        </p:nvSpPr>
        <p:spPr>
          <a:xfrm>
            <a:off x="5073480" y="5394240"/>
            <a:ext cx="0" cy="5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3"/>
          <p:cNvSpPr/>
          <p:nvPr/>
        </p:nvSpPr>
        <p:spPr>
          <a:xfrm>
            <a:off x="4952880" y="5457960"/>
            <a:ext cx="228600" cy="37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7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261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047G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42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14089A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4"/>
          <p:cNvSpPr/>
          <p:nvPr/>
        </p:nvSpPr>
        <p:spPr>
          <a:xfrm>
            <a:off x="4997520" y="4832280"/>
            <a:ext cx="0" cy="54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5"/>
          <p:cNvSpPr/>
          <p:nvPr/>
        </p:nvSpPr>
        <p:spPr>
          <a:xfrm>
            <a:off x="5853240" y="5267160"/>
            <a:ext cx="0" cy="657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6"/>
          <p:cNvSpPr/>
          <p:nvPr/>
        </p:nvSpPr>
        <p:spPr>
          <a:xfrm>
            <a:off x="5668920" y="5267160"/>
            <a:ext cx="0" cy="657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7"/>
          <p:cNvSpPr/>
          <p:nvPr/>
        </p:nvSpPr>
        <p:spPr>
          <a:xfrm flipV="1">
            <a:off x="1635120" y="2763720"/>
            <a:ext cx="0" cy="3160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8"/>
          <p:cNvSpPr/>
          <p:nvPr/>
        </p:nvSpPr>
        <p:spPr>
          <a:xfrm>
            <a:off x="1413000" y="1481040"/>
            <a:ext cx="0" cy="4443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9"/>
          <p:cNvSpPr/>
          <p:nvPr/>
        </p:nvSpPr>
        <p:spPr>
          <a:xfrm>
            <a:off x="2038320" y="3619440"/>
            <a:ext cx="2666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0"/>
          <p:cNvSpPr/>
          <p:nvPr/>
        </p:nvSpPr>
        <p:spPr>
          <a:xfrm>
            <a:off x="2046240" y="3621240"/>
            <a:ext cx="0" cy="603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1"/>
          <p:cNvSpPr/>
          <p:nvPr/>
        </p:nvSpPr>
        <p:spPr>
          <a:xfrm>
            <a:off x="2879640" y="4224240"/>
            <a:ext cx="3657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2"/>
          <p:cNvSpPr/>
          <p:nvPr/>
        </p:nvSpPr>
        <p:spPr>
          <a:xfrm>
            <a:off x="1619280" y="2752560"/>
            <a:ext cx="1676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3"/>
          <p:cNvSpPr/>
          <p:nvPr/>
        </p:nvSpPr>
        <p:spPr>
          <a:xfrm>
            <a:off x="2378160" y="3621240"/>
            <a:ext cx="0" cy="2303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4"/>
          <p:cNvSpPr/>
          <p:nvPr/>
        </p:nvSpPr>
        <p:spPr>
          <a:xfrm flipV="1">
            <a:off x="6540480" y="4223880"/>
            <a:ext cx="0" cy="328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5"/>
          <p:cNvSpPr/>
          <p:nvPr/>
        </p:nvSpPr>
        <p:spPr>
          <a:xfrm>
            <a:off x="990720" y="438120"/>
            <a:ext cx="838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6"/>
          <p:cNvSpPr/>
          <p:nvPr/>
        </p:nvSpPr>
        <p:spPr>
          <a:xfrm>
            <a:off x="1460520" y="328680"/>
            <a:ext cx="0" cy="109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7"/>
          <p:cNvSpPr/>
          <p:nvPr/>
        </p:nvSpPr>
        <p:spPr>
          <a:xfrm flipV="1">
            <a:off x="1003320" y="441360"/>
            <a:ext cx="0" cy="1447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18"/>
          <p:cNvSpPr/>
          <p:nvPr/>
        </p:nvSpPr>
        <p:spPr>
          <a:xfrm>
            <a:off x="866880" y="1892160"/>
            <a:ext cx="274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9"/>
          <p:cNvSpPr/>
          <p:nvPr/>
        </p:nvSpPr>
        <p:spPr>
          <a:xfrm flipV="1">
            <a:off x="866880" y="1892160"/>
            <a:ext cx="0" cy="4029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0"/>
          <p:cNvSpPr/>
          <p:nvPr/>
        </p:nvSpPr>
        <p:spPr>
          <a:xfrm flipV="1">
            <a:off x="1139760" y="1891800"/>
            <a:ext cx="0" cy="4038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21"/>
          <p:cNvSpPr/>
          <p:nvPr/>
        </p:nvSpPr>
        <p:spPr>
          <a:xfrm>
            <a:off x="3292560" y="2763720"/>
            <a:ext cx="0" cy="857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2"/>
          <p:cNvSpPr/>
          <p:nvPr/>
        </p:nvSpPr>
        <p:spPr>
          <a:xfrm>
            <a:off x="1409760" y="1476360"/>
            <a:ext cx="914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3"/>
          <p:cNvSpPr/>
          <p:nvPr/>
        </p:nvSpPr>
        <p:spPr>
          <a:xfrm>
            <a:off x="2332080" y="1481040"/>
            <a:ext cx="0" cy="1262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24"/>
          <p:cNvSpPr/>
          <p:nvPr/>
        </p:nvSpPr>
        <p:spPr>
          <a:xfrm>
            <a:off x="1828800" y="438120"/>
            <a:ext cx="0" cy="10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5"/>
          <p:cNvSpPr/>
          <p:nvPr/>
        </p:nvSpPr>
        <p:spPr>
          <a:xfrm>
            <a:off x="4708440" y="3621240"/>
            <a:ext cx="0" cy="603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6"/>
          <p:cNvSpPr/>
          <p:nvPr/>
        </p:nvSpPr>
        <p:spPr>
          <a:xfrm>
            <a:off x="4638600" y="3657600"/>
            <a:ext cx="136440" cy="37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0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37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43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06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30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27"/>
          <p:cNvSpPr/>
          <p:nvPr/>
        </p:nvSpPr>
        <p:spPr>
          <a:xfrm>
            <a:off x="6473880" y="4292640"/>
            <a:ext cx="136440" cy="8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19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28"/>
          <p:cNvSpPr/>
          <p:nvPr/>
        </p:nvSpPr>
        <p:spPr>
          <a:xfrm>
            <a:off x="6080040" y="4552920"/>
            <a:ext cx="1098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29"/>
          <p:cNvSpPr/>
          <p:nvPr/>
        </p:nvSpPr>
        <p:spPr>
          <a:xfrm flipH="1" flipV="1">
            <a:off x="7607160" y="4882680"/>
            <a:ext cx="12960" cy="29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0"/>
          <p:cNvSpPr/>
          <p:nvPr/>
        </p:nvSpPr>
        <p:spPr>
          <a:xfrm>
            <a:off x="7543800" y="4916520"/>
            <a:ext cx="136440" cy="15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7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45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1"/>
          <p:cNvSpPr/>
          <p:nvPr/>
        </p:nvSpPr>
        <p:spPr>
          <a:xfrm>
            <a:off x="7086600" y="5181480"/>
            <a:ext cx="1371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32"/>
          <p:cNvSpPr/>
          <p:nvPr/>
        </p:nvSpPr>
        <p:spPr>
          <a:xfrm>
            <a:off x="3200400" y="2797200"/>
            <a:ext cx="182520" cy="582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4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1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79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95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94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02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72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29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3"/>
          <p:cNvSpPr/>
          <p:nvPr/>
        </p:nvSpPr>
        <p:spPr>
          <a:xfrm>
            <a:off x="1960560" y="3755880"/>
            <a:ext cx="182520" cy="228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9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5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241G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4"/>
          <p:cNvSpPr/>
          <p:nvPr/>
        </p:nvSpPr>
        <p:spPr>
          <a:xfrm>
            <a:off x="1914480" y="42195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35"/>
          <p:cNvSpPr/>
          <p:nvPr/>
        </p:nvSpPr>
        <p:spPr>
          <a:xfrm>
            <a:off x="1920960" y="4224240"/>
            <a:ext cx="0" cy="1700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36"/>
          <p:cNvSpPr/>
          <p:nvPr/>
        </p:nvSpPr>
        <p:spPr>
          <a:xfrm>
            <a:off x="2149560" y="4224240"/>
            <a:ext cx="0" cy="1700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37"/>
          <p:cNvSpPr/>
          <p:nvPr/>
        </p:nvSpPr>
        <p:spPr>
          <a:xfrm>
            <a:off x="2073240" y="4300560"/>
            <a:ext cx="136440" cy="1150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18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1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45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56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41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51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40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26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88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211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15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07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76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64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38"/>
          <p:cNvSpPr/>
          <p:nvPr/>
        </p:nvSpPr>
        <p:spPr>
          <a:xfrm>
            <a:off x="1828800" y="4300560"/>
            <a:ext cx="182520" cy="724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4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45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38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34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2756A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34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55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59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95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23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39"/>
          <p:cNvSpPr/>
          <p:nvPr/>
        </p:nvSpPr>
        <p:spPr>
          <a:xfrm>
            <a:off x="2286000" y="4286160"/>
            <a:ext cx="182520" cy="1362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4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7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45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1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3566T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39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43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30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46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54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61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53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68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3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53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55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15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63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46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40"/>
          <p:cNvSpPr/>
          <p:nvPr/>
        </p:nvSpPr>
        <p:spPr>
          <a:xfrm>
            <a:off x="2560680" y="4224240"/>
            <a:ext cx="136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41"/>
          <p:cNvSpPr/>
          <p:nvPr/>
        </p:nvSpPr>
        <p:spPr>
          <a:xfrm>
            <a:off x="2560680" y="4224240"/>
            <a:ext cx="0" cy="1700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42"/>
          <p:cNvSpPr/>
          <p:nvPr/>
        </p:nvSpPr>
        <p:spPr>
          <a:xfrm>
            <a:off x="2697120" y="4224240"/>
            <a:ext cx="0" cy="1700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43"/>
          <p:cNvSpPr/>
          <p:nvPr/>
        </p:nvSpPr>
        <p:spPr>
          <a:xfrm>
            <a:off x="2635200" y="4433760"/>
            <a:ext cx="138240" cy="267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65C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59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71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44"/>
          <p:cNvSpPr/>
          <p:nvPr/>
        </p:nvSpPr>
        <p:spPr>
          <a:xfrm>
            <a:off x="2498760" y="4724280"/>
            <a:ext cx="136440" cy="29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8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30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59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55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45"/>
          <p:cNvSpPr/>
          <p:nvPr/>
        </p:nvSpPr>
        <p:spPr>
          <a:xfrm>
            <a:off x="4114800" y="4992840"/>
            <a:ext cx="0" cy="93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46"/>
          <p:cNvSpPr/>
          <p:nvPr/>
        </p:nvSpPr>
        <p:spPr>
          <a:xfrm>
            <a:off x="4051440" y="5170320"/>
            <a:ext cx="137880" cy="37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22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93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16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33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51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47"/>
          <p:cNvSpPr/>
          <p:nvPr/>
        </p:nvSpPr>
        <p:spPr>
          <a:xfrm>
            <a:off x="3054240" y="4229280"/>
            <a:ext cx="0" cy="1752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48"/>
          <p:cNvSpPr/>
          <p:nvPr/>
        </p:nvSpPr>
        <p:spPr>
          <a:xfrm>
            <a:off x="2962440" y="5208480"/>
            <a:ext cx="182520" cy="511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4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7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8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04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39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16308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49"/>
          <p:cNvSpPr/>
          <p:nvPr/>
        </p:nvSpPr>
        <p:spPr>
          <a:xfrm flipH="1">
            <a:off x="5760720" y="4224240"/>
            <a:ext cx="3240" cy="10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50"/>
          <p:cNvSpPr/>
          <p:nvPr/>
        </p:nvSpPr>
        <p:spPr>
          <a:xfrm>
            <a:off x="5673600" y="5267160"/>
            <a:ext cx="182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51"/>
          <p:cNvSpPr/>
          <p:nvPr/>
        </p:nvSpPr>
        <p:spPr>
          <a:xfrm>
            <a:off x="5692680" y="4498920"/>
            <a:ext cx="138240" cy="29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43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37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47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52"/>
          <p:cNvSpPr/>
          <p:nvPr/>
        </p:nvSpPr>
        <p:spPr>
          <a:xfrm>
            <a:off x="5591160" y="5413320"/>
            <a:ext cx="136440" cy="37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35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15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93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46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53"/>
          <p:cNvSpPr/>
          <p:nvPr/>
        </p:nvSpPr>
        <p:spPr>
          <a:xfrm>
            <a:off x="5778360" y="5413320"/>
            <a:ext cx="136800" cy="37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110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59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00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85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31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54"/>
          <p:cNvSpPr/>
          <p:nvPr/>
        </p:nvSpPr>
        <p:spPr>
          <a:xfrm>
            <a:off x="4892760" y="5391000"/>
            <a:ext cx="0" cy="5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55"/>
          <p:cNvSpPr/>
          <p:nvPr/>
        </p:nvSpPr>
        <p:spPr>
          <a:xfrm>
            <a:off x="4811760" y="5502240"/>
            <a:ext cx="155520" cy="267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7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35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16308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56"/>
          <p:cNvSpPr/>
          <p:nvPr/>
        </p:nvSpPr>
        <p:spPr>
          <a:xfrm>
            <a:off x="3417840" y="4498920"/>
            <a:ext cx="0" cy="1425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57"/>
          <p:cNvSpPr/>
          <p:nvPr/>
        </p:nvSpPr>
        <p:spPr>
          <a:xfrm>
            <a:off x="3349800" y="5370480"/>
            <a:ext cx="182520" cy="8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20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58"/>
          <p:cNvSpPr/>
          <p:nvPr/>
        </p:nvSpPr>
        <p:spPr>
          <a:xfrm>
            <a:off x="3565440" y="5102280"/>
            <a:ext cx="0" cy="822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59"/>
          <p:cNvSpPr/>
          <p:nvPr/>
        </p:nvSpPr>
        <p:spPr>
          <a:xfrm>
            <a:off x="3505320" y="5335560"/>
            <a:ext cx="182520" cy="8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16308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60"/>
          <p:cNvSpPr/>
          <p:nvPr/>
        </p:nvSpPr>
        <p:spPr>
          <a:xfrm>
            <a:off x="4572000" y="4552920"/>
            <a:ext cx="0" cy="1371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61"/>
          <p:cNvSpPr/>
          <p:nvPr/>
        </p:nvSpPr>
        <p:spPr>
          <a:xfrm>
            <a:off x="4505400" y="5273640"/>
            <a:ext cx="133200" cy="37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30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83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41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18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11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62"/>
          <p:cNvSpPr/>
          <p:nvPr/>
        </p:nvSpPr>
        <p:spPr>
          <a:xfrm flipH="1">
            <a:off x="2871360" y="4224240"/>
            <a:ext cx="3240" cy="1697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63"/>
          <p:cNvSpPr/>
          <p:nvPr/>
        </p:nvSpPr>
        <p:spPr>
          <a:xfrm>
            <a:off x="2806560" y="4981680"/>
            <a:ext cx="138240" cy="441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53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28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70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77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41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89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64"/>
          <p:cNvSpPr/>
          <p:nvPr/>
        </p:nvSpPr>
        <p:spPr>
          <a:xfrm>
            <a:off x="3200400" y="4227480"/>
            <a:ext cx="0" cy="1716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65"/>
          <p:cNvSpPr/>
          <p:nvPr/>
        </p:nvSpPr>
        <p:spPr>
          <a:xfrm>
            <a:off x="3135240" y="5137200"/>
            <a:ext cx="138240" cy="228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4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83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66"/>
          <p:cNvSpPr/>
          <p:nvPr/>
        </p:nvSpPr>
        <p:spPr>
          <a:xfrm>
            <a:off x="4297320" y="4992840"/>
            <a:ext cx="11160" cy="93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67"/>
          <p:cNvSpPr/>
          <p:nvPr/>
        </p:nvSpPr>
        <p:spPr>
          <a:xfrm>
            <a:off x="4210200" y="5068800"/>
            <a:ext cx="182520" cy="653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90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18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17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82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13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13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31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29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16308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68"/>
          <p:cNvSpPr/>
          <p:nvPr/>
        </p:nvSpPr>
        <p:spPr>
          <a:xfrm>
            <a:off x="3562200" y="5102280"/>
            <a:ext cx="365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69"/>
          <p:cNvSpPr/>
          <p:nvPr/>
        </p:nvSpPr>
        <p:spPr>
          <a:xfrm>
            <a:off x="3749760" y="4498920"/>
            <a:ext cx="0" cy="603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70"/>
          <p:cNvSpPr/>
          <p:nvPr/>
        </p:nvSpPr>
        <p:spPr>
          <a:xfrm>
            <a:off x="3657600" y="4557600"/>
            <a:ext cx="182520" cy="29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13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014A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71"/>
          <p:cNvSpPr/>
          <p:nvPr/>
        </p:nvSpPr>
        <p:spPr>
          <a:xfrm>
            <a:off x="3930480" y="5102280"/>
            <a:ext cx="0" cy="838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72"/>
          <p:cNvSpPr/>
          <p:nvPr/>
        </p:nvSpPr>
        <p:spPr>
          <a:xfrm>
            <a:off x="3749760" y="4992840"/>
            <a:ext cx="0" cy="93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73"/>
          <p:cNvSpPr/>
          <p:nvPr/>
        </p:nvSpPr>
        <p:spPr>
          <a:xfrm>
            <a:off x="3828960" y="5348160"/>
            <a:ext cx="184320" cy="37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9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84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69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59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16308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74"/>
          <p:cNvSpPr/>
          <p:nvPr/>
        </p:nvSpPr>
        <p:spPr>
          <a:xfrm>
            <a:off x="3687840" y="5391000"/>
            <a:ext cx="137880" cy="8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78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75"/>
          <p:cNvSpPr/>
          <p:nvPr/>
        </p:nvSpPr>
        <p:spPr>
          <a:xfrm>
            <a:off x="7581960" y="5181480"/>
            <a:ext cx="0" cy="762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76"/>
          <p:cNvSpPr/>
          <p:nvPr/>
        </p:nvSpPr>
        <p:spPr>
          <a:xfrm>
            <a:off x="4997520" y="4827600"/>
            <a:ext cx="365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77"/>
          <p:cNvSpPr/>
          <p:nvPr/>
        </p:nvSpPr>
        <p:spPr>
          <a:xfrm>
            <a:off x="5165640" y="4552920"/>
            <a:ext cx="0" cy="274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78"/>
          <p:cNvSpPr/>
          <p:nvPr/>
        </p:nvSpPr>
        <p:spPr>
          <a:xfrm>
            <a:off x="5121360" y="4619520"/>
            <a:ext cx="136440" cy="68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4400" bIns="144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69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79"/>
          <p:cNvSpPr/>
          <p:nvPr/>
        </p:nvSpPr>
        <p:spPr>
          <a:xfrm>
            <a:off x="8061480" y="5181480"/>
            <a:ext cx="0" cy="762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80"/>
          <p:cNvSpPr/>
          <p:nvPr/>
        </p:nvSpPr>
        <p:spPr>
          <a:xfrm>
            <a:off x="8226360" y="5181480"/>
            <a:ext cx="0" cy="762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81"/>
          <p:cNvSpPr/>
          <p:nvPr/>
        </p:nvSpPr>
        <p:spPr>
          <a:xfrm>
            <a:off x="8163000" y="5391000"/>
            <a:ext cx="136440" cy="441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8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6261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66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83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40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69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82"/>
          <p:cNvSpPr/>
          <p:nvPr/>
        </p:nvSpPr>
        <p:spPr>
          <a:xfrm>
            <a:off x="6642000" y="4883040"/>
            <a:ext cx="0" cy="1067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83"/>
          <p:cNvSpPr/>
          <p:nvPr/>
        </p:nvSpPr>
        <p:spPr>
          <a:xfrm>
            <a:off x="7007400" y="57150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84"/>
          <p:cNvSpPr/>
          <p:nvPr/>
        </p:nvSpPr>
        <p:spPr>
          <a:xfrm>
            <a:off x="6934320" y="541008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85"/>
          <p:cNvSpPr/>
          <p:nvPr/>
        </p:nvSpPr>
        <p:spPr>
          <a:xfrm>
            <a:off x="6858000" y="5486400"/>
            <a:ext cx="136440" cy="196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430T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90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86"/>
          <p:cNvSpPr/>
          <p:nvPr/>
        </p:nvSpPr>
        <p:spPr>
          <a:xfrm>
            <a:off x="4754520" y="4552920"/>
            <a:ext cx="0" cy="1371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87"/>
          <p:cNvSpPr/>
          <p:nvPr/>
        </p:nvSpPr>
        <p:spPr>
          <a:xfrm>
            <a:off x="4692600" y="5329080"/>
            <a:ext cx="133560" cy="15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4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6261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88"/>
          <p:cNvSpPr/>
          <p:nvPr/>
        </p:nvSpPr>
        <p:spPr>
          <a:xfrm>
            <a:off x="6004080" y="5159520"/>
            <a:ext cx="0" cy="761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89"/>
          <p:cNvSpPr/>
          <p:nvPr/>
        </p:nvSpPr>
        <p:spPr>
          <a:xfrm>
            <a:off x="5934240" y="5214960"/>
            <a:ext cx="136440" cy="29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4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37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68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90"/>
          <p:cNvSpPr/>
          <p:nvPr/>
        </p:nvSpPr>
        <p:spPr>
          <a:xfrm>
            <a:off x="6230880" y="5157720"/>
            <a:ext cx="0" cy="493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91"/>
          <p:cNvSpPr/>
          <p:nvPr/>
        </p:nvSpPr>
        <p:spPr>
          <a:xfrm>
            <a:off x="6146640" y="5245200"/>
            <a:ext cx="152640" cy="37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143A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4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44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74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76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92"/>
          <p:cNvSpPr/>
          <p:nvPr/>
        </p:nvSpPr>
        <p:spPr>
          <a:xfrm>
            <a:off x="5264280" y="5378400"/>
            <a:ext cx="0" cy="609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93"/>
          <p:cNvSpPr/>
          <p:nvPr/>
        </p:nvSpPr>
        <p:spPr>
          <a:xfrm>
            <a:off x="5452920" y="5376960"/>
            <a:ext cx="5040" cy="547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94"/>
          <p:cNvSpPr/>
          <p:nvPr/>
        </p:nvSpPr>
        <p:spPr>
          <a:xfrm>
            <a:off x="5222880" y="5641920"/>
            <a:ext cx="138240" cy="8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4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95"/>
          <p:cNvSpPr/>
          <p:nvPr/>
        </p:nvSpPr>
        <p:spPr>
          <a:xfrm>
            <a:off x="5378400" y="5621400"/>
            <a:ext cx="136440" cy="228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4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50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96"/>
          <p:cNvSpPr/>
          <p:nvPr/>
        </p:nvSpPr>
        <p:spPr>
          <a:xfrm>
            <a:off x="6477120" y="4552920"/>
            <a:ext cx="0" cy="1390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97"/>
          <p:cNvSpPr/>
          <p:nvPr/>
        </p:nvSpPr>
        <p:spPr>
          <a:xfrm>
            <a:off x="6427800" y="5310360"/>
            <a:ext cx="136440" cy="8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77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98"/>
          <p:cNvSpPr/>
          <p:nvPr/>
        </p:nvSpPr>
        <p:spPr>
          <a:xfrm>
            <a:off x="8381880" y="5334120"/>
            <a:ext cx="0" cy="609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99"/>
          <p:cNvSpPr/>
          <p:nvPr/>
        </p:nvSpPr>
        <p:spPr>
          <a:xfrm>
            <a:off x="7489800" y="5410080"/>
            <a:ext cx="182520" cy="37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9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7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2515A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29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62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100"/>
          <p:cNvSpPr/>
          <p:nvPr/>
        </p:nvSpPr>
        <p:spPr>
          <a:xfrm>
            <a:off x="7988400" y="5334120"/>
            <a:ext cx="137880" cy="441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18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4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79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69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1068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63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101"/>
          <p:cNvSpPr/>
          <p:nvPr/>
        </p:nvSpPr>
        <p:spPr>
          <a:xfrm>
            <a:off x="6004080" y="51577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102"/>
          <p:cNvSpPr/>
          <p:nvPr/>
        </p:nvSpPr>
        <p:spPr>
          <a:xfrm>
            <a:off x="6076800" y="4557600"/>
            <a:ext cx="0" cy="600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103"/>
          <p:cNvSpPr/>
          <p:nvPr/>
        </p:nvSpPr>
        <p:spPr>
          <a:xfrm>
            <a:off x="6005520" y="4614840"/>
            <a:ext cx="138240" cy="29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7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07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20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61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104"/>
          <p:cNvSpPr/>
          <p:nvPr/>
        </p:nvSpPr>
        <p:spPr>
          <a:xfrm>
            <a:off x="6159600" y="5651640"/>
            <a:ext cx="182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105"/>
          <p:cNvSpPr/>
          <p:nvPr/>
        </p:nvSpPr>
        <p:spPr>
          <a:xfrm>
            <a:off x="6159600" y="5651640"/>
            <a:ext cx="0" cy="304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Line 106"/>
          <p:cNvSpPr/>
          <p:nvPr/>
        </p:nvSpPr>
        <p:spPr>
          <a:xfrm>
            <a:off x="6340320" y="5651640"/>
            <a:ext cx="0" cy="304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107"/>
          <p:cNvSpPr/>
          <p:nvPr/>
        </p:nvSpPr>
        <p:spPr>
          <a:xfrm>
            <a:off x="6122880" y="5707080"/>
            <a:ext cx="90720" cy="8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18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108"/>
          <p:cNvSpPr/>
          <p:nvPr/>
        </p:nvSpPr>
        <p:spPr>
          <a:xfrm>
            <a:off x="1569960" y="3441600"/>
            <a:ext cx="136440" cy="1433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1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44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1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33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60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98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16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85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96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13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27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22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23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24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31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37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4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12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27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109"/>
          <p:cNvSpPr/>
          <p:nvPr/>
        </p:nvSpPr>
        <p:spPr>
          <a:xfrm>
            <a:off x="1359000" y="2133720"/>
            <a:ext cx="136440" cy="2923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 </a:t>
            </a: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1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30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2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38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45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0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3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8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4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24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37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88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1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67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43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46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64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16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1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79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82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55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02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34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34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69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2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69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16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05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39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67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52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56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73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77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30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64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74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86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110"/>
          <p:cNvSpPr/>
          <p:nvPr/>
        </p:nvSpPr>
        <p:spPr>
          <a:xfrm>
            <a:off x="2186280" y="1566720"/>
            <a:ext cx="104400" cy="81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18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0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1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33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4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62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70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16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33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66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83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01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 Box 111"/>
          <p:cNvSpPr/>
          <p:nvPr/>
        </p:nvSpPr>
        <p:spPr>
          <a:xfrm>
            <a:off x="2308320" y="1536840"/>
            <a:ext cx="136440" cy="937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7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10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1068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18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2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94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64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04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21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71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68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11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25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 Box 112"/>
          <p:cNvSpPr/>
          <p:nvPr/>
        </p:nvSpPr>
        <p:spPr>
          <a:xfrm>
            <a:off x="1752480" y="493560"/>
            <a:ext cx="138240" cy="763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6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93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463A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63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75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29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97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51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15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63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113"/>
          <p:cNvSpPr/>
          <p:nvPr/>
        </p:nvSpPr>
        <p:spPr>
          <a:xfrm>
            <a:off x="907920" y="496800"/>
            <a:ext cx="187560" cy="653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5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77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859A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28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91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108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90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9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66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114"/>
          <p:cNvSpPr/>
          <p:nvPr/>
        </p:nvSpPr>
        <p:spPr>
          <a:xfrm>
            <a:off x="779400" y="2057400"/>
            <a:ext cx="163440" cy="186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0800" bIns="36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45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3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5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99A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39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28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41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49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80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84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43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77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65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23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43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06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24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30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64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31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37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132A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25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25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55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115"/>
          <p:cNvSpPr/>
          <p:nvPr/>
        </p:nvSpPr>
        <p:spPr>
          <a:xfrm>
            <a:off x="1057320" y="2057400"/>
            <a:ext cx="166680" cy="2430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0800" bIns="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3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6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4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3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1639A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71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6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6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36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463A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56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67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07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16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80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22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3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71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21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15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41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98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44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929T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56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20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21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95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69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78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01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13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25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61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116"/>
          <p:cNvSpPr/>
          <p:nvPr/>
        </p:nvSpPr>
        <p:spPr>
          <a:xfrm>
            <a:off x="4664160" y="4073400"/>
            <a:ext cx="93600" cy="102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21600" bIns="216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 Box 117"/>
          <p:cNvSpPr/>
          <p:nvPr/>
        </p:nvSpPr>
        <p:spPr>
          <a:xfrm>
            <a:off x="2330280" y="4059360"/>
            <a:ext cx="93600" cy="102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21600" bIns="216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 Box 118"/>
          <p:cNvSpPr/>
          <p:nvPr/>
        </p:nvSpPr>
        <p:spPr>
          <a:xfrm>
            <a:off x="2000160" y="4059360"/>
            <a:ext cx="93600" cy="102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21600" bIns="216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119"/>
          <p:cNvSpPr/>
          <p:nvPr/>
        </p:nvSpPr>
        <p:spPr>
          <a:xfrm>
            <a:off x="2606760" y="3621240"/>
            <a:ext cx="0" cy="603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120"/>
          <p:cNvSpPr/>
          <p:nvPr/>
        </p:nvSpPr>
        <p:spPr>
          <a:xfrm>
            <a:off x="2540160" y="3676680"/>
            <a:ext cx="136440" cy="29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47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58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337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83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121"/>
          <p:cNvSpPr/>
          <p:nvPr/>
        </p:nvSpPr>
        <p:spPr>
          <a:xfrm>
            <a:off x="2568600" y="4059360"/>
            <a:ext cx="93600" cy="102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21600" bIns="216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122"/>
          <p:cNvSpPr/>
          <p:nvPr/>
        </p:nvSpPr>
        <p:spPr>
          <a:xfrm>
            <a:off x="2301840" y="3840120"/>
            <a:ext cx="136440" cy="132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0800" bIns="108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85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46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 Box 123"/>
          <p:cNvSpPr/>
          <p:nvPr/>
        </p:nvSpPr>
        <p:spPr>
          <a:xfrm>
            <a:off x="5694480" y="4892760"/>
            <a:ext cx="136440" cy="88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14400" bIns="14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 Box 124"/>
          <p:cNvSpPr/>
          <p:nvPr/>
        </p:nvSpPr>
        <p:spPr>
          <a:xfrm>
            <a:off x="3687840" y="4952880"/>
            <a:ext cx="152280" cy="88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4400" bIns="14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 Box 125"/>
          <p:cNvSpPr/>
          <p:nvPr/>
        </p:nvSpPr>
        <p:spPr>
          <a:xfrm>
            <a:off x="5075280" y="4734000"/>
            <a:ext cx="165240" cy="59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c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 Box 126"/>
          <p:cNvSpPr/>
          <p:nvPr/>
        </p:nvSpPr>
        <p:spPr>
          <a:xfrm>
            <a:off x="6492960" y="4422600"/>
            <a:ext cx="136440" cy="106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 Box 127"/>
          <p:cNvSpPr/>
          <p:nvPr/>
        </p:nvSpPr>
        <p:spPr>
          <a:xfrm>
            <a:off x="5991120" y="4986360"/>
            <a:ext cx="169920" cy="88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14400" bIns="14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a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128"/>
          <p:cNvSpPr/>
          <p:nvPr/>
        </p:nvSpPr>
        <p:spPr>
          <a:xfrm>
            <a:off x="2822400" y="4552920"/>
            <a:ext cx="138240" cy="6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0800" bIns="108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24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 Box 129"/>
          <p:cNvSpPr/>
          <p:nvPr/>
        </p:nvSpPr>
        <p:spPr>
          <a:xfrm>
            <a:off x="2800440" y="4765680"/>
            <a:ext cx="149040" cy="106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i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130"/>
          <p:cNvSpPr/>
          <p:nvPr/>
        </p:nvSpPr>
        <p:spPr>
          <a:xfrm>
            <a:off x="2987640" y="4419720"/>
            <a:ext cx="136440" cy="132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0800" bIns="108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78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86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 Box 131"/>
          <p:cNvSpPr/>
          <p:nvPr/>
        </p:nvSpPr>
        <p:spPr>
          <a:xfrm>
            <a:off x="2962440" y="4765680"/>
            <a:ext cx="182520" cy="106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h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 Box 132"/>
          <p:cNvSpPr/>
          <p:nvPr/>
        </p:nvSpPr>
        <p:spPr>
          <a:xfrm>
            <a:off x="3349800" y="4951440"/>
            <a:ext cx="136440" cy="106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f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 Box 133"/>
          <p:cNvSpPr/>
          <p:nvPr/>
        </p:nvSpPr>
        <p:spPr>
          <a:xfrm>
            <a:off x="4506840" y="4883040"/>
            <a:ext cx="165240" cy="88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14400" bIns="14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c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34"/>
          <p:cNvSpPr/>
          <p:nvPr/>
        </p:nvSpPr>
        <p:spPr>
          <a:xfrm>
            <a:off x="3138480" y="4552920"/>
            <a:ext cx="138240" cy="6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0800" bIns="108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81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135"/>
          <p:cNvSpPr/>
          <p:nvPr/>
        </p:nvSpPr>
        <p:spPr>
          <a:xfrm>
            <a:off x="3144960" y="4770360"/>
            <a:ext cx="137880" cy="106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 Box 136"/>
          <p:cNvSpPr/>
          <p:nvPr/>
        </p:nvSpPr>
        <p:spPr>
          <a:xfrm>
            <a:off x="4675320" y="5102280"/>
            <a:ext cx="165240" cy="88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14400" bIns="14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c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137"/>
          <p:cNvSpPr/>
          <p:nvPr/>
        </p:nvSpPr>
        <p:spPr>
          <a:xfrm>
            <a:off x="6411960" y="4718160"/>
            <a:ext cx="136440" cy="5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7200" bIns="72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41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 Box 138"/>
          <p:cNvSpPr/>
          <p:nvPr/>
        </p:nvSpPr>
        <p:spPr>
          <a:xfrm>
            <a:off x="6400800" y="4981680"/>
            <a:ext cx="201600" cy="106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a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139"/>
          <p:cNvSpPr/>
          <p:nvPr/>
        </p:nvSpPr>
        <p:spPr>
          <a:xfrm>
            <a:off x="4892760" y="5391000"/>
            <a:ext cx="182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140"/>
          <p:cNvSpPr/>
          <p:nvPr/>
        </p:nvSpPr>
        <p:spPr>
          <a:xfrm>
            <a:off x="4933800" y="4921200"/>
            <a:ext cx="136800" cy="29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55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53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90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61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Line 141"/>
          <p:cNvSpPr/>
          <p:nvPr/>
        </p:nvSpPr>
        <p:spPr>
          <a:xfrm>
            <a:off x="5268960" y="5376960"/>
            <a:ext cx="182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Line 142"/>
          <p:cNvSpPr/>
          <p:nvPr/>
        </p:nvSpPr>
        <p:spPr>
          <a:xfrm>
            <a:off x="5361120" y="4827600"/>
            <a:ext cx="0" cy="54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143"/>
          <p:cNvSpPr/>
          <p:nvPr/>
        </p:nvSpPr>
        <p:spPr>
          <a:xfrm>
            <a:off x="5286240" y="4954680"/>
            <a:ext cx="136800" cy="228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18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49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Line 144"/>
          <p:cNvSpPr/>
          <p:nvPr/>
        </p:nvSpPr>
        <p:spPr>
          <a:xfrm>
            <a:off x="4114800" y="4992840"/>
            <a:ext cx="182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Line 145"/>
          <p:cNvSpPr/>
          <p:nvPr/>
        </p:nvSpPr>
        <p:spPr>
          <a:xfrm>
            <a:off x="4208400" y="4498920"/>
            <a:ext cx="0" cy="493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146"/>
          <p:cNvSpPr/>
          <p:nvPr/>
        </p:nvSpPr>
        <p:spPr>
          <a:xfrm>
            <a:off x="4146480" y="4599000"/>
            <a:ext cx="136440" cy="132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0800" bIns="108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86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48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 Box 147"/>
          <p:cNvSpPr/>
          <p:nvPr/>
        </p:nvSpPr>
        <p:spPr>
          <a:xfrm>
            <a:off x="4130640" y="4807080"/>
            <a:ext cx="165240" cy="106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 Box 148"/>
          <p:cNvSpPr/>
          <p:nvPr/>
        </p:nvSpPr>
        <p:spPr>
          <a:xfrm>
            <a:off x="4695840" y="4664160"/>
            <a:ext cx="138240" cy="29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97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13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85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88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 Box 149"/>
          <p:cNvSpPr/>
          <p:nvPr/>
        </p:nvSpPr>
        <p:spPr>
          <a:xfrm>
            <a:off x="3352680" y="4656240"/>
            <a:ext cx="138240" cy="15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9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354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Text Box 150"/>
          <p:cNvSpPr/>
          <p:nvPr/>
        </p:nvSpPr>
        <p:spPr>
          <a:xfrm>
            <a:off x="958680" y="1316160"/>
            <a:ext cx="120960" cy="106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 Box 151"/>
          <p:cNvSpPr/>
          <p:nvPr/>
        </p:nvSpPr>
        <p:spPr>
          <a:xfrm>
            <a:off x="1789200" y="1316160"/>
            <a:ext cx="122040" cy="106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 Box 152"/>
          <p:cNvSpPr/>
          <p:nvPr/>
        </p:nvSpPr>
        <p:spPr>
          <a:xfrm>
            <a:off x="3262320" y="3457440"/>
            <a:ext cx="92160" cy="102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1600" bIns="21600" anchor="t">
            <a:sp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 Box 153"/>
          <p:cNvSpPr/>
          <p:nvPr/>
        </p:nvSpPr>
        <p:spPr>
          <a:xfrm>
            <a:off x="1349280" y="1646280"/>
            <a:ext cx="136800" cy="8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03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 Box 154"/>
          <p:cNvSpPr/>
          <p:nvPr/>
        </p:nvSpPr>
        <p:spPr>
          <a:xfrm>
            <a:off x="1362240" y="1865160"/>
            <a:ext cx="182520" cy="106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 Box 155"/>
          <p:cNvSpPr/>
          <p:nvPr/>
        </p:nvSpPr>
        <p:spPr>
          <a:xfrm>
            <a:off x="1432080" y="219240"/>
            <a:ext cx="137880" cy="12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49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 Box 156"/>
          <p:cNvSpPr/>
          <p:nvPr/>
        </p:nvSpPr>
        <p:spPr>
          <a:xfrm>
            <a:off x="1560600" y="3071880"/>
            <a:ext cx="182520" cy="102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1600" bIns="21600" anchor="t">
            <a:sp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1a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 Box 157"/>
          <p:cNvSpPr/>
          <p:nvPr/>
        </p:nvSpPr>
        <p:spPr>
          <a:xfrm>
            <a:off x="2263680" y="2595600"/>
            <a:ext cx="160560" cy="102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1600" bIns="21600" anchor="t">
            <a:sp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1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Line 158"/>
          <p:cNvSpPr/>
          <p:nvPr/>
        </p:nvSpPr>
        <p:spPr>
          <a:xfrm>
            <a:off x="4572000" y="4552920"/>
            <a:ext cx="59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159"/>
          <p:cNvSpPr/>
          <p:nvPr/>
        </p:nvSpPr>
        <p:spPr>
          <a:xfrm>
            <a:off x="4800600" y="4224240"/>
            <a:ext cx="0" cy="328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 Box 160"/>
          <p:cNvSpPr/>
          <p:nvPr/>
        </p:nvSpPr>
        <p:spPr>
          <a:xfrm>
            <a:off x="4772160" y="4265640"/>
            <a:ext cx="91800" cy="8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44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Line 161"/>
          <p:cNvSpPr/>
          <p:nvPr/>
        </p:nvSpPr>
        <p:spPr>
          <a:xfrm>
            <a:off x="6645240" y="4883040"/>
            <a:ext cx="959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162"/>
          <p:cNvSpPr/>
          <p:nvPr/>
        </p:nvSpPr>
        <p:spPr>
          <a:xfrm>
            <a:off x="7178760" y="4552920"/>
            <a:ext cx="0" cy="330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 Box 163"/>
          <p:cNvSpPr/>
          <p:nvPr/>
        </p:nvSpPr>
        <p:spPr>
          <a:xfrm>
            <a:off x="7126200" y="4602240"/>
            <a:ext cx="138240" cy="8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22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 Box 164"/>
          <p:cNvSpPr/>
          <p:nvPr/>
        </p:nvSpPr>
        <p:spPr>
          <a:xfrm>
            <a:off x="7499520" y="5099040"/>
            <a:ext cx="208080" cy="59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a1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Line 165"/>
          <p:cNvSpPr/>
          <p:nvPr/>
        </p:nvSpPr>
        <p:spPr>
          <a:xfrm flipH="1">
            <a:off x="3428640" y="4498920"/>
            <a:ext cx="777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Line 166"/>
          <p:cNvSpPr/>
          <p:nvPr/>
        </p:nvSpPr>
        <p:spPr>
          <a:xfrm>
            <a:off x="3749760" y="4224240"/>
            <a:ext cx="0" cy="274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 Box 167"/>
          <p:cNvSpPr/>
          <p:nvPr/>
        </p:nvSpPr>
        <p:spPr>
          <a:xfrm>
            <a:off x="3714840" y="4332240"/>
            <a:ext cx="136440" cy="8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4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 Box 168"/>
          <p:cNvSpPr/>
          <p:nvPr/>
        </p:nvSpPr>
        <p:spPr>
          <a:xfrm>
            <a:off x="7089840" y="4745160"/>
            <a:ext cx="169920" cy="88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14400" bIns="14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a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 Box 169"/>
          <p:cNvSpPr/>
          <p:nvPr/>
        </p:nvSpPr>
        <p:spPr>
          <a:xfrm>
            <a:off x="4724280" y="4408560"/>
            <a:ext cx="127080" cy="88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14400" bIns="14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 Box 170"/>
          <p:cNvSpPr/>
          <p:nvPr/>
        </p:nvSpPr>
        <p:spPr>
          <a:xfrm>
            <a:off x="5257800" y="5273640"/>
            <a:ext cx="203400" cy="88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14400" bIns="14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c1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 Box 171"/>
          <p:cNvSpPr/>
          <p:nvPr/>
        </p:nvSpPr>
        <p:spPr>
          <a:xfrm>
            <a:off x="4897440" y="5267160"/>
            <a:ext cx="208080" cy="88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14400" bIns="14400" anchor="t">
            <a:spAutoFit/>
          </a:bodyPr>
          <a:p>
            <a:pPr algn="ctr"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1c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Line 172"/>
          <p:cNvSpPr/>
          <p:nvPr/>
        </p:nvSpPr>
        <p:spPr>
          <a:xfrm>
            <a:off x="6821640" y="5715000"/>
            <a:ext cx="182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Line 173"/>
          <p:cNvSpPr/>
          <p:nvPr/>
        </p:nvSpPr>
        <p:spPr>
          <a:xfrm>
            <a:off x="6821640" y="57150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Text Box 174"/>
          <p:cNvSpPr/>
          <p:nvPr/>
        </p:nvSpPr>
        <p:spPr>
          <a:xfrm>
            <a:off x="6765840" y="5775480"/>
            <a:ext cx="136440" cy="8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6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Text Box 175"/>
          <p:cNvSpPr/>
          <p:nvPr/>
        </p:nvSpPr>
        <p:spPr>
          <a:xfrm>
            <a:off x="6934320" y="5845320"/>
            <a:ext cx="137880" cy="5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7200" bIns="72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85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 Box 176"/>
          <p:cNvSpPr/>
          <p:nvPr/>
        </p:nvSpPr>
        <p:spPr>
          <a:xfrm>
            <a:off x="911160" y="1447920"/>
            <a:ext cx="182520" cy="37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1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278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30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44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177"/>
          <p:cNvSpPr/>
          <p:nvPr/>
        </p:nvSpPr>
        <p:spPr>
          <a:xfrm>
            <a:off x="7086600" y="51814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Line 178"/>
          <p:cNvSpPr/>
          <p:nvPr/>
        </p:nvSpPr>
        <p:spPr>
          <a:xfrm>
            <a:off x="6934320" y="5410080"/>
            <a:ext cx="457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179"/>
          <p:cNvSpPr/>
          <p:nvPr/>
        </p:nvSpPr>
        <p:spPr>
          <a:xfrm>
            <a:off x="7391520" y="5410080"/>
            <a:ext cx="0" cy="5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Line 180"/>
          <p:cNvSpPr/>
          <p:nvPr/>
        </p:nvSpPr>
        <p:spPr>
          <a:xfrm>
            <a:off x="7746840" y="5181480"/>
            <a:ext cx="0" cy="762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 Box 181"/>
          <p:cNvSpPr/>
          <p:nvPr/>
        </p:nvSpPr>
        <p:spPr>
          <a:xfrm>
            <a:off x="7016760" y="5248440"/>
            <a:ext cx="136440" cy="12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7200" bIns="72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74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08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 Box 182"/>
          <p:cNvSpPr/>
          <p:nvPr/>
        </p:nvSpPr>
        <p:spPr>
          <a:xfrm>
            <a:off x="7315200" y="5486400"/>
            <a:ext cx="136440" cy="37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1638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47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6261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31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772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Line 183"/>
          <p:cNvSpPr/>
          <p:nvPr/>
        </p:nvSpPr>
        <p:spPr>
          <a:xfrm>
            <a:off x="7899480" y="5181480"/>
            <a:ext cx="0" cy="762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 Box 184"/>
          <p:cNvSpPr/>
          <p:nvPr/>
        </p:nvSpPr>
        <p:spPr>
          <a:xfrm>
            <a:off x="7696080" y="5562720"/>
            <a:ext cx="152640" cy="8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62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 Box 185"/>
          <p:cNvSpPr/>
          <p:nvPr/>
        </p:nvSpPr>
        <p:spPr>
          <a:xfrm>
            <a:off x="7823160" y="5481720"/>
            <a:ext cx="136440" cy="15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559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06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Line 186"/>
          <p:cNvSpPr/>
          <p:nvPr/>
        </p:nvSpPr>
        <p:spPr>
          <a:xfrm>
            <a:off x="7194600" y="5813280"/>
            <a:ext cx="0" cy="152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Line 187"/>
          <p:cNvSpPr/>
          <p:nvPr/>
        </p:nvSpPr>
        <p:spPr>
          <a:xfrm>
            <a:off x="7010280" y="5813280"/>
            <a:ext cx="182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 Box 188"/>
          <p:cNvSpPr/>
          <p:nvPr/>
        </p:nvSpPr>
        <p:spPr>
          <a:xfrm>
            <a:off x="6934320" y="5740560"/>
            <a:ext cx="137880" cy="5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7200" bIns="7200" anchor="t">
            <a:spAutoFit/>
          </a:bodyPr>
          <a:p>
            <a:pPr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6261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Line 189"/>
          <p:cNvSpPr/>
          <p:nvPr/>
        </p:nvSpPr>
        <p:spPr>
          <a:xfrm>
            <a:off x="8534520" y="5334120"/>
            <a:ext cx="0" cy="609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Text Box 190"/>
          <p:cNvSpPr/>
          <p:nvPr/>
        </p:nvSpPr>
        <p:spPr>
          <a:xfrm>
            <a:off x="8315280" y="5514840"/>
            <a:ext cx="138240" cy="132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0800" bIns="108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18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43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Line 191"/>
          <p:cNvSpPr/>
          <p:nvPr/>
        </p:nvSpPr>
        <p:spPr>
          <a:xfrm>
            <a:off x="8458200" y="5181480"/>
            <a:ext cx="0" cy="152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Line 192"/>
          <p:cNvSpPr/>
          <p:nvPr/>
        </p:nvSpPr>
        <p:spPr>
          <a:xfrm>
            <a:off x="8385120" y="5334120"/>
            <a:ext cx="146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Text Box 193"/>
          <p:cNvSpPr/>
          <p:nvPr/>
        </p:nvSpPr>
        <p:spPr>
          <a:xfrm>
            <a:off x="8474040" y="5562720"/>
            <a:ext cx="136440" cy="8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23400" bIns="234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76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Text Box 194"/>
          <p:cNvSpPr/>
          <p:nvPr/>
        </p:nvSpPr>
        <p:spPr>
          <a:xfrm>
            <a:off x="8381880" y="5241960"/>
            <a:ext cx="136800" cy="6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0800" bIns="10800" anchor="t">
            <a:spAutoFit/>
          </a:bodyPr>
          <a:p>
            <a:pPr algn="ctr">
              <a:lnSpc>
                <a:spcPct val="65000"/>
              </a:lnSpc>
              <a:spcBef>
                <a:spcPts val="249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1" lang="en-US" sz="4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1638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Text Box 195"/>
          <p:cNvSpPr/>
          <p:nvPr/>
        </p:nvSpPr>
        <p:spPr>
          <a:xfrm rot="18900000">
            <a:off x="1216080" y="6271920"/>
            <a:ext cx="274680" cy="2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bfj347_EF54557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Text Box 196"/>
          <p:cNvSpPr/>
          <p:nvPr/>
        </p:nvSpPr>
        <p:spPr>
          <a:xfrm rot="18900000">
            <a:off x="417600" y="6329160"/>
            <a:ext cx="164880" cy="16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byn326_EF54558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Text Box 197"/>
          <p:cNvSpPr/>
          <p:nvPr/>
        </p:nvSpPr>
        <p:spPr>
          <a:xfrm rot="18900000">
            <a:off x="691920" y="6329160"/>
            <a:ext cx="182520" cy="16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byn351_EF54556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Text Box 198"/>
          <p:cNvSpPr/>
          <p:nvPr/>
        </p:nvSpPr>
        <p:spPr>
          <a:xfrm rot="18900000">
            <a:off x="993600" y="6322680"/>
            <a:ext cx="21924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byn371_EF54558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 Box 199"/>
          <p:cNvSpPr/>
          <p:nvPr/>
        </p:nvSpPr>
        <p:spPr>
          <a:xfrm rot="18900000">
            <a:off x="1469520" y="6340320"/>
            <a:ext cx="136800" cy="168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bvnm7_EF54558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 Box 200"/>
          <p:cNvSpPr/>
          <p:nvPr/>
        </p:nvSpPr>
        <p:spPr>
          <a:xfrm rot="18900000">
            <a:off x="1851120" y="6219360"/>
            <a:ext cx="18252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nxr_AF48686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 Box 201"/>
          <p:cNvSpPr/>
          <p:nvPr/>
        </p:nvSpPr>
        <p:spPr>
          <a:xfrm rot="18900000">
            <a:off x="1985760" y="6316200"/>
            <a:ext cx="136440" cy="168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b342_EF54557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Text Box 202"/>
          <p:cNvSpPr/>
          <p:nvPr/>
        </p:nvSpPr>
        <p:spPr>
          <a:xfrm rot="18900000">
            <a:off x="2298600" y="6335640"/>
            <a:ext cx="13824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aba722_EF54556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 Box 203"/>
          <p:cNvSpPr/>
          <p:nvPr/>
        </p:nvSpPr>
        <p:spPr>
          <a:xfrm rot="18900000">
            <a:off x="2168280" y="6297120"/>
            <a:ext cx="136440" cy="168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b365_EF54557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Text Box 204"/>
          <p:cNvSpPr/>
          <p:nvPr/>
        </p:nvSpPr>
        <p:spPr>
          <a:xfrm rot="18900000">
            <a:off x="3691080" y="6352920"/>
            <a:ext cx="137880" cy="16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bfj349_EF54556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Text Box 205"/>
          <p:cNvSpPr/>
          <p:nvPr/>
        </p:nvSpPr>
        <p:spPr>
          <a:xfrm rot="18900000">
            <a:off x="4851360" y="6351120"/>
            <a:ext cx="138240" cy="168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imh42_EF54558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Text Box 206"/>
          <p:cNvSpPr/>
          <p:nvPr/>
        </p:nvSpPr>
        <p:spPr>
          <a:xfrm rot="18900000">
            <a:off x="2633400" y="6311520"/>
            <a:ext cx="18252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a15_EF54557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Text Box 207"/>
          <p:cNvSpPr/>
          <p:nvPr/>
        </p:nvSpPr>
        <p:spPr>
          <a:xfrm rot="18900000">
            <a:off x="5306760" y="6288120"/>
            <a:ext cx="13644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iq7_EF54557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Text Box 208"/>
          <p:cNvSpPr/>
          <p:nvPr/>
        </p:nvSpPr>
        <p:spPr>
          <a:xfrm rot="18900000">
            <a:off x="5459400" y="6325920"/>
            <a:ext cx="136440" cy="16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hg184_EF54557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Text Box 209"/>
          <p:cNvSpPr/>
          <p:nvPr/>
        </p:nvSpPr>
        <p:spPr>
          <a:xfrm rot="18900000">
            <a:off x="4520880" y="6295680"/>
            <a:ext cx="182520" cy="16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uzu2_EF54558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Text Box 210"/>
          <p:cNvSpPr/>
          <p:nvPr/>
        </p:nvSpPr>
        <p:spPr>
          <a:xfrm rot="18900000">
            <a:off x="3166920" y="6312960"/>
            <a:ext cx="182880" cy="168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vfj348_EF54557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 Box 211"/>
          <p:cNvSpPr/>
          <p:nvPr/>
        </p:nvSpPr>
        <p:spPr>
          <a:xfrm rot="18900000">
            <a:off x="2984400" y="6295680"/>
            <a:ext cx="2286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bdb6_EF54558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Text Box 212"/>
          <p:cNvSpPr/>
          <p:nvPr/>
        </p:nvSpPr>
        <p:spPr>
          <a:xfrm rot="18900000">
            <a:off x="4162320" y="6280200"/>
            <a:ext cx="18432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aba1_EF54557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 Box 213"/>
          <p:cNvSpPr/>
          <p:nvPr/>
        </p:nvSpPr>
        <p:spPr>
          <a:xfrm rot="18900000">
            <a:off x="2493720" y="6283080"/>
            <a:ext cx="182520" cy="16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bjx4_EF54557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Text Box 214"/>
          <p:cNvSpPr/>
          <p:nvPr/>
        </p:nvSpPr>
        <p:spPr>
          <a:xfrm rot="18900000">
            <a:off x="2824200" y="6311520"/>
            <a:ext cx="183960" cy="16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uzu4_EF54558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Text Box 215"/>
          <p:cNvSpPr/>
          <p:nvPr/>
        </p:nvSpPr>
        <p:spPr>
          <a:xfrm rot="18900000">
            <a:off x="4068720" y="6171840"/>
            <a:ext cx="182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Z_AF48685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Text Box 216"/>
          <p:cNvSpPr/>
          <p:nvPr/>
        </p:nvSpPr>
        <p:spPr>
          <a:xfrm rot="18900000">
            <a:off x="3678120" y="6186240"/>
            <a:ext cx="182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x_AF48685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Text Box 217"/>
          <p:cNvSpPr/>
          <p:nvPr/>
        </p:nvSpPr>
        <p:spPr>
          <a:xfrm rot="18900000">
            <a:off x="3463920" y="6221160"/>
            <a:ext cx="182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hb_AF48687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Text Box 218"/>
          <p:cNvSpPr/>
          <p:nvPr/>
        </p:nvSpPr>
        <p:spPr>
          <a:xfrm rot="18900000">
            <a:off x="5178600" y="6221160"/>
            <a:ext cx="182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rhL_AF48686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Text Box 219"/>
          <p:cNvSpPr/>
          <p:nvPr/>
        </p:nvSpPr>
        <p:spPr>
          <a:xfrm rot="18900000">
            <a:off x="4745160" y="6257520"/>
            <a:ext cx="182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imh_AF48686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 Box 220"/>
          <p:cNvSpPr/>
          <p:nvPr/>
        </p:nvSpPr>
        <p:spPr>
          <a:xfrm rot="18900000">
            <a:off x="6907320" y="6229080"/>
            <a:ext cx="182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qh_AF48687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 Box 221"/>
          <p:cNvSpPr/>
          <p:nvPr/>
        </p:nvSpPr>
        <p:spPr>
          <a:xfrm rot="18900000">
            <a:off x="5635440" y="6270120"/>
            <a:ext cx="18252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mei2_EF54558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 Box 222"/>
          <p:cNvSpPr/>
          <p:nvPr/>
        </p:nvSpPr>
        <p:spPr>
          <a:xfrm rot="18900000">
            <a:off x="7058160" y="6254280"/>
            <a:ext cx="182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anh_AF48687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 Box 223"/>
          <p:cNvSpPr/>
          <p:nvPr/>
        </p:nvSpPr>
        <p:spPr>
          <a:xfrm rot="18900000">
            <a:off x="7278840" y="6222600"/>
            <a:ext cx="182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b_AF48687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 Box 224"/>
          <p:cNvSpPr/>
          <p:nvPr/>
        </p:nvSpPr>
        <p:spPr>
          <a:xfrm rot="18900000">
            <a:off x="7445520" y="6229080"/>
            <a:ext cx="1839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inh_AF48686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Text Box 225"/>
          <p:cNvSpPr/>
          <p:nvPr/>
        </p:nvSpPr>
        <p:spPr>
          <a:xfrm rot="18900000">
            <a:off x="7597800" y="6229080"/>
            <a:ext cx="182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n_AF48686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Text Box 226"/>
          <p:cNvSpPr/>
          <p:nvPr/>
        </p:nvSpPr>
        <p:spPr>
          <a:xfrm rot="18900000">
            <a:off x="6399360" y="6197400"/>
            <a:ext cx="182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chAF48686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Text Box 227"/>
          <p:cNvSpPr/>
          <p:nvPr/>
        </p:nvSpPr>
        <p:spPr>
          <a:xfrm rot="18900000">
            <a:off x="6680160" y="6262200"/>
            <a:ext cx="1843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ush_AF48687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Text Box 228"/>
          <p:cNvSpPr/>
          <p:nvPr/>
        </p:nvSpPr>
        <p:spPr>
          <a:xfrm rot="18900000">
            <a:off x="6550200" y="6216120"/>
            <a:ext cx="182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p_AF48686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Text Box 229"/>
          <p:cNvSpPr/>
          <p:nvPr/>
        </p:nvSpPr>
        <p:spPr>
          <a:xfrm rot="18900000">
            <a:off x="4414680" y="6262200"/>
            <a:ext cx="1828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zsh_AF48686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Text Box 230"/>
          <p:cNvSpPr/>
          <p:nvPr/>
        </p:nvSpPr>
        <p:spPr>
          <a:xfrm rot="18900000">
            <a:off x="6289560" y="6136920"/>
            <a:ext cx="182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AF48685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Text Box 231"/>
          <p:cNvSpPr/>
          <p:nvPr/>
        </p:nvSpPr>
        <p:spPr>
          <a:xfrm rot="18900000">
            <a:off x="7773840" y="6210000"/>
            <a:ext cx="1828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ch_AF48686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Text Box 232"/>
          <p:cNvSpPr/>
          <p:nvPr/>
        </p:nvSpPr>
        <p:spPr>
          <a:xfrm rot="18900000">
            <a:off x="7893000" y="6260760"/>
            <a:ext cx="182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Zmsh_AF48685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Text Box 233"/>
          <p:cNvSpPr/>
          <p:nvPr/>
        </p:nvSpPr>
        <p:spPr>
          <a:xfrm rot="18900000">
            <a:off x="8021520" y="6291000"/>
            <a:ext cx="184320" cy="16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ei10_EF54557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Text Box 234"/>
          <p:cNvSpPr/>
          <p:nvPr/>
        </p:nvSpPr>
        <p:spPr>
          <a:xfrm rot="18900000">
            <a:off x="8173800" y="6270120"/>
            <a:ext cx="18252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269_EF54559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 Box 235"/>
          <p:cNvSpPr/>
          <p:nvPr/>
        </p:nvSpPr>
        <p:spPr>
          <a:xfrm rot="18900000">
            <a:off x="5761080" y="6322680"/>
            <a:ext cx="182520" cy="2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p4014_EF54558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 Box 236"/>
          <p:cNvSpPr/>
          <p:nvPr/>
        </p:nvSpPr>
        <p:spPr>
          <a:xfrm rot="18900000">
            <a:off x="5927760" y="6292440"/>
            <a:ext cx="244440" cy="10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>
              <a:lnSpc>
                <a:spcPct val="65000"/>
              </a:lnSpc>
              <a:spcBef>
                <a:spcPts val="37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p442_EF54558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TextBox 236"/>
          <p:cNvSpPr/>
          <p:nvPr/>
        </p:nvSpPr>
        <p:spPr>
          <a:xfrm>
            <a:off x="4000680" y="214200"/>
            <a:ext cx="3500280" cy="22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data file 3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assification tree of 42 (near-)complete mtDNA sequences in clade A in Figure 1. The nucleotide variants presented on the branches are scored relative to a reference sequence EF545567 (sample saba722). Suffixes “A”, “G”, “C”, and “T” indicate transversions. Recurrent mutations are underlined. The order of mutations on a branch is arbitrary. The nested relationship among the haplogroups is demonstrated by their position on the respective branche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27T17:31:17Z</dcterms:created>
  <dc:creator>Huairong</dc:creator>
  <dc:description/>
  <dc:language>en-US</dc:language>
  <cp:lastModifiedBy>Med-IT</cp:lastModifiedBy>
  <dcterms:modified xsi:type="dcterms:W3CDTF">2007-11-08T18:14:40Z</dcterms:modified>
  <cp:revision>18</cp:revision>
  <dc:subject/>
  <dc:title>Slide 1</dc:title>
</cp:coreProperties>
</file>